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1"/>
  </p:notesMasterIdLst>
  <p:sldIdLst>
    <p:sldId id="345" r:id="rId2"/>
    <p:sldId id="279" r:id="rId3"/>
    <p:sldId id="330" r:id="rId4"/>
    <p:sldId id="281" r:id="rId5"/>
    <p:sldId id="275" r:id="rId6"/>
    <p:sldId id="283" r:id="rId7"/>
    <p:sldId id="284" r:id="rId8"/>
    <p:sldId id="285" r:id="rId9"/>
    <p:sldId id="286" r:id="rId10"/>
    <p:sldId id="287" r:id="rId11"/>
    <p:sldId id="289" r:id="rId12"/>
    <p:sldId id="272" r:id="rId13"/>
    <p:sldId id="291" r:id="rId14"/>
    <p:sldId id="296" r:id="rId15"/>
    <p:sldId id="348" r:id="rId16"/>
    <p:sldId id="339" r:id="rId17"/>
    <p:sldId id="273" r:id="rId18"/>
    <p:sldId id="290" r:id="rId19"/>
    <p:sldId id="274" r:id="rId20"/>
    <p:sldId id="347" r:id="rId21"/>
    <p:sldId id="293" r:id="rId22"/>
    <p:sldId id="346" r:id="rId23"/>
    <p:sldId id="349" r:id="rId24"/>
    <p:sldId id="342" r:id="rId25"/>
    <p:sldId id="276" r:id="rId26"/>
    <p:sldId id="338" r:id="rId27"/>
    <p:sldId id="344" r:id="rId28"/>
    <p:sldId id="308" r:id="rId29"/>
    <p:sldId id="310" r:id="rId3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sa Prahl" initials="RP" lastIdx="1" clrIdx="0">
    <p:extLst>
      <p:ext uri="{19B8F6BF-5375-455C-9EA6-DF929625EA0E}">
        <p15:presenceInfo xmlns:p15="http://schemas.microsoft.com/office/powerpoint/2012/main" userId="S::U1114537@usq.edu.au::83bc8d5a-bf0f-4a2b-ae3b-15c4cd981ad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8F985"/>
    <a:srgbClr val="99FF33"/>
    <a:srgbClr val="FFCCFF"/>
    <a:srgbClr val="669900"/>
    <a:srgbClr val="33CC33"/>
    <a:srgbClr val="99FFCC"/>
    <a:srgbClr val="FFCC00"/>
    <a:srgbClr val="CCCC00"/>
    <a:srgbClr val="2F528F"/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50236FC-3BD9-4D5C-A70A-379D742AE607}" v="1" dt="2021-06-03T00:42:53.7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793" autoAdjust="0"/>
    <p:restoredTop sz="62618" autoAdjust="0"/>
  </p:normalViewPr>
  <p:slideViewPr>
    <p:cSldViewPr snapToGrid="0">
      <p:cViewPr varScale="1">
        <p:scale>
          <a:sx n="38" d="100"/>
          <a:sy n="38" d="100"/>
        </p:scale>
        <p:origin x="174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38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commentAuthors" Target="commentAuthors.xml"/><Relationship Id="rId37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sa Prahl" userId="83bc8d5a-bf0f-4a2b-ae3b-15c4cd981ad7" providerId="ADAL" clId="{BBF293F0-C9AD-4508-849C-153F34DDB728}"/>
    <pc:docChg chg="custSel modSld">
      <pc:chgData name="Rosa Prahl" userId="83bc8d5a-bf0f-4a2b-ae3b-15c4cd981ad7" providerId="ADAL" clId="{BBF293F0-C9AD-4508-849C-153F34DDB728}" dt="2021-05-27T22:19:03.902" v="278" actId="20577"/>
      <pc:docMkLst>
        <pc:docMk/>
      </pc:docMkLst>
      <pc:sldChg chg="modNotesTx">
        <pc:chgData name="Rosa Prahl" userId="83bc8d5a-bf0f-4a2b-ae3b-15c4cd981ad7" providerId="ADAL" clId="{BBF293F0-C9AD-4508-849C-153F34DDB728}" dt="2021-05-27T22:19:03.902" v="278" actId="20577"/>
        <pc:sldMkLst>
          <pc:docMk/>
          <pc:sldMk cId="775738875" sldId="274"/>
        </pc:sldMkLst>
      </pc:sldChg>
    </pc:docChg>
  </pc:docChgLst>
  <pc:docChgLst>
    <pc:chgData name="Rosa Prahl" userId="83bc8d5a-bf0f-4a2b-ae3b-15c4cd981ad7" providerId="ADAL" clId="{550236FC-3BD9-4D5C-A70A-379D742AE607}"/>
    <pc:docChg chg="modSld">
      <pc:chgData name="Rosa Prahl" userId="83bc8d5a-bf0f-4a2b-ae3b-15c4cd981ad7" providerId="ADAL" clId="{550236FC-3BD9-4D5C-A70A-379D742AE607}" dt="2021-06-03T00:45:48.805" v="72" actId="20577"/>
      <pc:docMkLst>
        <pc:docMk/>
      </pc:docMkLst>
      <pc:sldChg chg="modNotesTx">
        <pc:chgData name="Rosa Prahl" userId="83bc8d5a-bf0f-4a2b-ae3b-15c4cd981ad7" providerId="ADAL" clId="{550236FC-3BD9-4D5C-A70A-379D742AE607}" dt="2021-06-03T00:45:23.358" v="71" actId="114"/>
        <pc:sldMkLst>
          <pc:docMk/>
          <pc:sldMk cId="951535620" sldId="279"/>
        </pc:sldMkLst>
      </pc:sldChg>
      <pc:sldChg chg="modNotesTx">
        <pc:chgData name="Rosa Prahl" userId="83bc8d5a-bf0f-4a2b-ae3b-15c4cd981ad7" providerId="ADAL" clId="{550236FC-3BD9-4D5C-A70A-379D742AE607}" dt="2021-06-03T00:45:48.805" v="72" actId="20577"/>
        <pc:sldMkLst>
          <pc:docMk/>
          <pc:sldMk cId="2037155430" sldId="29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CE7140-262F-4C7D-B3B6-18CAF19F1DFD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076F6A-8237-4DFA-A2C4-B75EE6D8704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7877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dirty="0"/>
              <a:t>The most common ITS2 secondary structure (S2), Model 1, found in the </a:t>
            </a:r>
            <a:r>
              <a:rPr lang="en-AU" i="1" dirty="0" err="1"/>
              <a:t>Ampelomyces</a:t>
            </a:r>
            <a:r>
              <a:rPr lang="en-AU" dirty="0"/>
              <a:t> population: from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hrocladiella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ugeoti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cium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milifolium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.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n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.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rberidis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. convolvuli, E.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ciferarum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, E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onym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. heracleid, E.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gon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dida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ysiphe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, 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foli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lovinomyces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choracearum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ignus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on 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tuca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, 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onti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oerysiphe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eopsidis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idium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,</a:t>
            </a:r>
            <a:r>
              <a:rPr lang="en-AU" i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llactinia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xin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AU" i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nnosa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1988905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dirty="0"/>
              <a:t>The single-stranded ring sequence between positions 4 and 9  is very conserved across all </a:t>
            </a:r>
            <a:r>
              <a:rPr lang="en-AU" i="1" dirty="0" err="1"/>
              <a:t>Ampelomyces</a:t>
            </a:r>
            <a:r>
              <a:rPr lang="en-AU" i="1" dirty="0"/>
              <a:t> </a:t>
            </a:r>
            <a:r>
              <a:rPr lang="en-AU" dirty="0"/>
              <a:t>species extracted from </a:t>
            </a:r>
            <a:r>
              <a:rPr lang="en-AU" i="1" dirty="0"/>
              <a:t>P. </a:t>
            </a:r>
            <a:r>
              <a:rPr lang="en-AU" i="1" dirty="0" err="1"/>
              <a:t>fusca</a:t>
            </a:r>
            <a:r>
              <a:rPr lang="en-AU" i="1" dirty="0"/>
              <a:t>. </a:t>
            </a:r>
            <a:r>
              <a:rPr lang="en-AU" i="0" dirty="0"/>
              <a:t>V</a:t>
            </a:r>
            <a:r>
              <a:rPr lang="en-AU" dirty="0"/>
              <a:t>ariations on Helix </a:t>
            </a:r>
            <a:r>
              <a:rPr lang="en-AU" i="0" dirty="0"/>
              <a:t>III </a:t>
            </a:r>
            <a:r>
              <a:rPr lang="en-AU" sz="1200" i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n-AU" i="0" dirty="0"/>
              <a:t> </a:t>
            </a:r>
            <a:r>
              <a:rPr lang="en-AU" dirty="0"/>
              <a:t>observed (C↔T) for the strain DQ49075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18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0527254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Variations were observed on Helix III (C↔T) from </a:t>
            </a:r>
            <a:r>
              <a:rPr lang="en-AU" i="1" dirty="0" err="1"/>
              <a:t>Ampelomyces</a:t>
            </a:r>
            <a:r>
              <a:rPr lang="en-AU" i="1" dirty="0"/>
              <a:t> </a:t>
            </a:r>
            <a:r>
              <a:rPr lang="en-AU" i="0" dirty="0"/>
              <a:t>sp. extracted from </a:t>
            </a:r>
            <a:r>
              <a:rPr lang="en-AU" i="1" dirty="0"/>
              <a:t>P. </a:t>
            </a:r>
            <a:r>
              <a:rPr lang="en-AU" i="1" dirty="0" err="1"/>
              <a:t>xanthii</a:t>
            </a:r>
            <a:r>
              <a:rPr lang="en-AU" i="1" dirty="0"/>
              <a:t> </a:t>
            </a:r>
            <a:r>
              <a:rPr lang="en-AU" i="0" dirty="0"/>
              <a:t>infecting </a:t>
            </a:r>
            <a:r>
              <a:rPr lang="en-AU" i="1" dirty="0"/>
              <a:t>C. maxima</a:t>
            </a:r>
            <a:r>
              <a:rPr lang="en-AU" i="0" dirty="0"/>
              <a:t>.</a:t>
            </a:r>
          </a:p>
          <a:p>
            <a:endParaRPr lang="en-AU" i="0" dirty="0"/>
          </a:p>
          <a:p>
            <a:r>
              <a:rPr lang="en-AU" i="0" dirty="0"/>
              <a:t>The motif UGGU-UU located on helix III were noticed on Models 2, 2-1 and 2-2 but on model 2-3 </a:t>
            </a:r>
            <a:r>
              <a:rPr lang="en-AU" i="0"/>
              <a:t>a transitional </a:t>
            </a:r>
            <a:r>
              <a:rPr lang="en-AU" i="0" dirty="0"/>
              <a:t>mutation occurred and U was changed </a:t>
            </a:r>
            <a:r>
              <a:rPr lang="en-AU" i="0"/>
              <a:t>by C (CGGU-UU).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19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022132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Models 4 and 5 were only found on </a:t>
            </a:r>
            <a:r>
              <a:rPr lang="en-AU" i="1" dirty="0" err="1"/>
              <a:t>Ampelomyces</a:t>
            </a:r>
            <a:r>
              <a:rPr lang="en-AU" dirty="0"/>
              <a:t> spp. extracted from apple powdery mildew (</a:t>
            </a:r>
            <a:r>
              <a:rPr lang="en-AU" i="1" dirty="0"/>
              <a:t>P. </a:t>
            </a:r>
            <a:r>
              <a:rPr lang="en-AU" i="1" dirty="0" err="1"/>
              <a:t>leucotricha</a:t>
            </a:r>
            <a:r>
              <a:rPr lang="en-AU" i="1" dirty="0"/>
              <a:t>)</a:t>
            </a:r>
            <a:r>
              <a:rPr lang="en-AU" dirty="0"/>
              <a:t> and </a:t>
            </a:r>
            <a:r>
              <a:rPr lang="en-AU" i="1" dirty="0"/>
              <a:t>P. </a:t>
            </a:r>
            <a:r>
              <a:rPr lang="en-AU" i="1" dirty="0" err="1"/>
              <a:t>ferruginea</a:t>
            </a:r>
            <a:r>
              <a:rPr lang="en-AU" i="0" dirty="0"/>
              <a:t>, respectivel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2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8320466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This ITS2 S2 Model 6 was only found on </a:t>
            </a:r>
            <a:r>
              <a:rPr lang="en-AU" i="1" dirty="0" err="1"/>
              <a:t>Ampelomyces</a:t>
            </a:r>
            <a:r>
              <a:rPr lang="en-AU" dirty="0"/>
              <a:t> spp. infecting grapes powdery mildew (</a:t>
            </a:r>
            <a:r>
              <a:rPr lang="en-AU" i="1" dirty="0"/>
              <a:t>Erysiphe </a:t>
            </a:r>
            <a:r>
              <a:rPr lang="en-AU" i="1" dirty="0" err="1"/>
              <a:t>necator</a:t>
            </a:r>
            <a:r>
              <a:rPr lang="en-AU" dirty="0"/>
              <a:t>). </a:t>
            </a:r>
          </a:p>
          <a:p>
            <a:r>
              <a:rPr lang="en-AU" dirty="0"/>
              <a:t>Variations in the hybridization model of the proximal stem was observed in </a:t>
            </a:r>
            <a:r>
              <a:rPr lang="en-AU" i="1" dirty="0" err="1"/>
              <a:t>Ampelomyces</a:t>
            </a:r>
            <a:r>
              <a:rPr lang="en-AU" dirty="0"/>
              <a:t> sp. (GenBank accession number HM125018) extracted from </a:t>
            </a:r>
            <a:r>
              <a:rPr lang="en-AU" dirty="0" err="1"/>
              <a:t>chasmothecia</a:t>
            </a:r>
            <a:r>
              <a:rPr lang="en-AU" dirty="0"/>
              <a:t> of </a:t>
            </a:r>
            <a:r>
              <a:rPr lang="en-AU" i="1" dirty="0"/>
              <a:t>Erysiphe </a:t>
            </a:r>
            <a:r>
              <a:rPr lang="en-AU" i="1" dirty="0" err="1"/>
              <a:t>necator</a:t>
            </a:r>
            <a:r>
              <a:rPr lang="en-AU" i="1" dirty="0"/>
              <a:t> </a:t>
            </a:r>
            <a:r>
              <a:rPr lang="en-AU" dirty="0"/>
              <a:t>(section </a:t>
            </a:r>
            <a:r>
              <a:rPr lang="en-AU" i="1" dirty="0" err="1"/>
              <a:t>Uncinula</a:t>
            </a:r>
            <a:r>
              <a:rPr lang="en-AU" i="1" dirty="0"/>
              <a:t>)</a:t>
            </a:r>
            <a:r>
              <a:rPr lang="en-AU" dirty="0"/>
              <a:t>. However, no changes were observed for those isolated from </a:t>
            </a:r>
            <a:r>
              <a:rPr lang="en-AU" i="1" dirty="0"/>
              <a:t>E. </a:t>
            </a:r>
            <a:r>
              <a:rPr lang="en-AU" i="1" dirty="0" err="1"/>
              <a:t>necator</a:t>
            </a:r>
            <a:r>
              <a:rPr lang="en-AU" i="1" dirty="0"/>
              <a:t> </a:t>
            </a:r>
            <a:r>
              <a:rPr lang="en-AU" i="0" dirty="0"/>
              <a:t>(section </a:t>
            </a:r>
            <a:r>
              <a:rPr lang="en-AU" i="1" dirty="0" err="1"/>
              <a:t>Uncinula</a:t>
            </a:r>
            <a:r>
              <a:rPr lang="en-AU" i="1" dirty="0"/>
              <a:t>)</a:t>
            </a:r>
            <a:r>
              <a:rPr lang="en-AU" i="0" dirty="0"/>
              <a:t> </a:t>
            </a:r>
            <a:r>
              <a:rPr lang="en-AU" dirty="0"/>
              <a:t>infecting </a:t>
            </a:r>
            <a:r>
              <a:rPr lang="en-AU" i="1" dirty="0"/>
              <a:t>V. </a:t>
            </a:r>
            <a:r>
              <a:rPr lang="en-AU" i="1" dirty="0" err="1"/>
              <a:t>riparia</a:t>
            </a:r>
            <a:r>
              <a:rPr lang="en-AU" i="1" dirty="0"/>
              <a:t> </a:t>
            </a:r>
            <a:r>
              <a:rPr lang="en-AU" i="0" dirty="0"/>
              <a:t>(HM125015-17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25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775772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ITS2 S2 from putative </a:t>
            </a:r>
            <a:r>
              <a:rPr lang="en-AU" i="1" dirty="0" err="1"/>
              <a:t>Ampelomyces</a:t>
            </a:r>
            <a:r>
              <a:rPr lang="en-AU" i="1" dirty="0"/>
              <a:t> </a:t>
            </a:r>
            <a:r>
              <a:rPr lang="en-AU" dirty="0"/>
              <a:t>spp. group 1. Notice the sequence (GTACCT) of the single-stranded ring between positions 1 and 10 (left right arrows in orange colour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28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456448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ITS2 S2 from putative </a:t>
            </a:r>
            <a:r>
              <a:rPr lang="en-AU" i="1" dirty="0" err="1"/>
              <a:t>Ampelomyces</a:t>
            </a:r>
            <a:r>
              <a:rPr lang="en-AU" dirty="0"/>
              <a:t> </a:t>
            </a:r>
            <a:r>
              <a:rPr lang="en-AU" i="1" dirty="0"/>
              <a:t> </a:t>
            </a:r>
            <a:r>
              <a:rPr lang="en-AU" i="0" dirty="0"/>
              <a:t>spp.</a:t>
            </a:r>
            <a:r>
              <a:rPr lang="en-AU" i="1" dirty="0"/>
              <a:t> </a:t>
            </a:r>
            <a:r>
              <a:rPr lang="en-AU" dirty="0"/>
              <a:t>groups 1 and 2. Notice the sequence (GTACCT) of the single-stranded ring (left right arrows in orange colour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29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0919662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dirty="0"/>
              <a:t>Variations in Model 1 were noticed on Helix II and on the single stranded ring between Helixes II and III; and III and IV (black arrows). Notice the sequence of the single-stranded ring between positions 4 and 10 (GTACCC), left right arrow in red colour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360341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i="0" dirty="0"/>
              <a:t>The most common ITS2 S2 (Model 1) found for </a:t>
            </a:r>
            <a:r>
              <a:rPr lang="en-AU" i="1" dirty="0" err="1"/>
              <a:t>Ampelomyces</a:t>
            </a:r>
            <a:r>
              <a:rPr lang="en-AU" i="1" dirty="0"/>
              <a:t> </a:t>
            </a:r>
            <a:r>
              <a:rPr lang="en-AU" i="0" dirty="0"/>
              <a:t>spp. isolated from </a:t>
            </a:r>
            <a:r>
              <a:rPr lang="en-AU" i="1" dirty="0"/>
              <a:t>A. </a:t>
            </a:r>
            <a:r>
              <a:rPr lang="en-AU" i="1" dirty="0" err="1"/>
              <a:t>mougeotii</a:t>
            </a:r>
            <a:r>
              <a:rPr lang="en-AU" i="1" dirty="0"/>
              <a:t> </a:t>
            </a:r>
            <a:r>
              <a:rPr lang="en-AU" i="0" dirty="0"/>
              <a:t>infecting </a:t>
            </a:r>
            <a:r>
              <a:rPr lang="en-AU" i="1" dirty="0"/>
              <a:t>L. </a:t>
            </a:r>
            <a:r>
              <a:rPr lang="en-AU" i="1" dirty="0" err="1"/>
              <a:t>hamilifolium</a:t>
            </a:r>
            <a:endParaRPr lang="en-AU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4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529821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5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0975161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6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742815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dirty="0"/>
              <a:t>The two most common structures found in </a:t>
            </a:r>
            <a:r>
              <a:rPr lang="en-AU" i="1" dirty="0"/>
              <a:t>G. </a:t>
            </a:r>
            <a:r>
              <a:rPr lang="en-AU" i="1" dirty="0" err="1"/>
              <a:t>cichoracearum</a:t>
            </a:r>
            <a:r>
              <a:rPr lang="en-AU" i="1" dirty="0"/>
              <a:t> </a:t>
            </a:r>
            <a:r>
              <a:rPr lang="en-AU" i="0" dirty="0"/>
              <a:t>Models 1 and 2</a:t>
            </a:r>
            <a:endParaRPr lang="en-AU" sz="1200" i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1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289520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In the same population of </a:t>
            </a:r>
            <a:r>
              <a:rPr lang="en-AU" i="1" dirty="0" err="1"/>
              <a:t>Ampelomyces</a:t>
            </a:r>
            <a:r>
              <a:rPr lang="en-AU" dirty="0"/>
              <a:t> infecting </a:t>
            </a:r>
            <a:r>
              <a:rPr lang="en-AU" i="1" dirty="0"/>
              <a:t>A. </a:t>
            </a:r>
            <a:r>
              <a:rPr lang="en-AU" i="1" dirty="0" err="1"/>
              <a:t>mougeotii</a:t>
            </a:r>
            <a:r>
              <a:rPr lang="en-AU" i="1" dirty="0"/>
              <a:t> </a:t>
            </a:r>
            <a:r>
              <a:rPr lang="en-AU" dirty="0"/>
              <a:t>other ITS2 S2 models (7 and 2) were found. Model 7 differed from Model 1 mostly on Helix III. These </a:t>
            </a:r>
            <a:r>
              <a:rPr lang="en-AU" i="0" dirty="0"/>
              <a:t>variations </a:t>
            </a:r>
            <a:r>
              <a:rPr lang="en-AU" dirty="0"/>
              <a:t>were found on the hairpin of Helix III (C↔T) and Helix IV (A↔T).</a:t>
            </a:r>
          </a:p>
          <a:p>
            <a:r>
              <a:rPr lang="en-AU" dirty="0"/>
              <a:t>Model 1 and 7 have a sequence GTACCC on the single-stranded ring (left right arrow in red colour) while the one from Model 2 is GTCTCC (left right arrow in blue colour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14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5679336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16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5071908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This is the common ITS2 S2 for </a:t>
            </a:r>
            <a:r>
              <a:rPr lang="en-AU" i="1" dirty="0" err="1"/>
              <a:t>Ampelomyces</a:t>
            </a:r>
            <a:r>
              <a:rPr lang="en-AU" dirty="0"/>
              <a:t> spp. extracted from </a:t>
            </a:r>
            <a:r>
              <a:rPr lang="en-AU" i="1" dirty="0"/>
              <a:t>P. </a:t>
            </a:r>
            <a:r>
              <a:rPr lang="en-AU" i="1" dirty="0" err="1"/>
              <a:t>fusca</a:t>
            </a:r>
            <a:r>
              <a:rPr lang="en-AU" i="1" dirty="0"/>
              <a:t> </a:t>
            </a:r>
            <a:r>
              <a:rPr lang="en-AU" i="0" dirty="0"/>
              <a:t>(Model 2)</a:t>
            </a:r>
            <a:r>
              <a:rPr lang="en-AU" i="1" dirty="0"/>
              <a:t>.</a:t>
            </a:r>
            <a:r>
              <a:rPr lang="en-AU" i="0" dirty="0"/>
              <a:t> Variations </a:t>
            </a:r>
            <a:r>
              <a:rPr lang="en-AU" dirty="0"/>
              <a:t>were noticed in the hairpin of Helix II C↔T (A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TS2 S2 Model 2 has the shortest stack on Helix IV and found in </a:t>
            </a:r>
            <a:r>
              <a:rPr lang="en-A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elomyces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076F6A-8237-4DFA-A2C4-B75EE6D8704D}" type="slidenum">
              <a:rPr lang="en-AU" smtClean="0"/>
              <a:t>17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21826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FB6ED5-3BEA-494F-994D-03A41A16DC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846058-6900-4765-BD28-8D4C23FF7B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2" indent="0" algn="ctr">
              <a:buNone/>
              <a:defRPr sz="2000"/>
            </a:lvl2pPr>
            <a:lvl3pPr marL="914423" indent="0" algn="ctr">
              <a:buNone/>
              <a:defRPr sz="1800"/>
            </a:lvl3pPr>
            <a:lvl4pPr marL="1371634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0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B05242-8A54-4DAA-9606-BA122814B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8325D-F737-411B-94EB-3E5077AF4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ACE3BC-7694-4798-845D-9A743A3F9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95604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B2ADD3-409A-4192-8717-DA34B63924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2E596F-A372-472F-A5AF-34E103FF81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772948-A38E-4395-9BFC-1809A1D24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8C4FE-06C0-4329-AC81-F342D4BF1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963BA0-FCE0-4479-9CCB-40D314636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9489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6275CC-CAC2-41BB-91B7-E84756ACD3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0E3E06-C0C5-4678-ACFE-9DEE651314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37E23D-A054-4B16-AEE3-418F95F8D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FD4000-BBF9-45EC-92FC-C98592FB8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2D8A1E-39F4-47BC-B009-DADEF8F267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98204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3DEB0-55FB-450C-81D3-1EA6B1A6F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F747DB-F654-436E-93E4-1D665A3852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A808C-109C-4127-A9DD-B2D7FC8D3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988B9A-12F0-4967-BAE7-FF276DF62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131179-FE00-40EE-8461-53E811343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57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AAD237-78E9-4AE7-9971-1791D50E4D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ABA7AD-53CC-4E9D-8A27-54A2A218FB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BA8673-A952-46C7-8931-7DF8D46BE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A3AF7B-6F78-4842-B48B-D2C5F3B84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100D32-00E5-493C-BF73-1C483593F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8938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95D554-4D0A-4CAC-9570-9E1D9F03BD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ED6D89-06B4-42DB-B8C9-30A0DD1ACD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F5A174-1E73-47B2-8810-678265D26D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B40D6A-3852-4423-91FF-BC6E96010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4F9553-86FA-4420-A1F2-D49EC969A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7DC4C3-6EE9-4E15-AF3A-5F2956F16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53247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22CE12-272A-4195-BEF4-621EF74849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98A60A-2113-4DF2-8056-F6AB617458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0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B0F177-71C0-40F9-9411-79C873C700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1C0A7C-B87E-4706-979F-EBA309CBDB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0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459B9AE-50CB-4856-858F-BDFE5BA388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77F717-1CDC-4AD2-8894-BAA69BF0B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CA7F89-A8F2-4CAE-8B45-EC8323B53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EB86F3-DF8E-41C3-B988-A5237D7F3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13655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774A6-78ED-41EC-9DBA-7669B0259A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D7FBB0-EA59-4C8E-9093-489725426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4C096A-70C9-4841-856B-3174C23C4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096B39-DFA8-474C-8B49-8EFBAC9D9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099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947F99-7FBE-44DA-B297-4ED96D21F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15F0F0-C1E3-42FA-9B1E-7D7E60E15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3AE343-1F25-4A41-9994-A2C73D071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2405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25100-82DE-4CE1-B9E7-3677B98E9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7954EB-63FE-46D6-BCE0-41323B6531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B29E0B-A480-4125-AAA5-9C16FBB9D7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0"/>
            </a:lvl2pPr>
            <a:lvl3pPr marL="914423" indent="0">
              <a:buNone/>
              <a:defRPr sz="1200"/>
            </a:lvl3pPr>
            <a:lvl4pPr marL="1371634" indent="0">
              <a:buNone/>
              <a:defRPr sz="1000"/>
            </a:lvl4pPr>
            <a:lvl5pPr marL="1828846" indent="0">
              <a:buNone/>
              <a:defRPr sz="1000"/>
            </a:lvl5pPr>
            <a:lvl6pPr marL="2286057" indent="0">
              <a:buNone/>
              <a:defRPr sz="1000"/>
            </a:lvl6pPr>
            <a:lvl7pPr marL="2743268" indent="0">
              <a:buNone/>
              <a:defRPr sz="1000"/>
            </a:lvl7pPr>
            <a:lvl8pPr marL="3200480" indent="0">
              <a:buNone/>
              <a:defRPr sz="1000"/>
            </a:lvl8pPr>
            <a:lvl9pPr marL="3657692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7EE3E4-E6C2-45EC-BFEA-095755CDC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DDCEEA-DE23-443A-85C8-6066671AE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9D198E-CFA2-44FD-889E-924AA6D47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250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BA3CF9-81C2-40F5-AC41-5EEB430137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BD5755-CF76-4E24-8436-A06C503FAB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2" indent="0">
              <a:buNone/>
              <a:defRPr sz="2800"/>
            </a:lvl2pPr>
            <a:lvl3pPr marL="914423" indent="0">
              <a:buNone/>
              <a:defRPr sz="2400"/>
            </a:lvl3pPr>
            <a:lvl4pPr marL="1371634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0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9007A4-D48F-4ED7-A9EC-F38ED883C5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0"/>
            </a:lvl2pPr>
            <a:lvl3pPr marL="914423" indent="0">
              <a:buNone/>
              <a:defRPr sz="1200"/>
            </a:lvl3pPr>
            <a:lvl4pPr marL="1371634" indent="0">
              <a:buNone/>
              <a:defRPr sz="1000"/>
            </a:lvl4pPr>
            <a:lvl5pPr marL="1828846" indent="0">
              <a:buNone/>
              <a:defRPr sz="1000"/>
            </a:lvl5pPr>
            <a:lvl6pPr marL="2286057" indent="0">
              <a:buNone/>
              <a:defRPr sz="1000"/>
            </a:lvl6pPr>
            <a:lvl7pPr marL="2743268" indent="0">
              <a:buNone/>
              <a:defRPr sz="1000"/>
            </a:lvl7pPr>
            <a:lvl8pPr marL="3200480" indent="0">
              <a:buNone/>
              <a:defRPr sz="1000"/>
            </a:lvl8pPr>
            <a:lvl9pPr marL="3657692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5A9DB2-E0FF-4EE4-863D-51F011FD67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7C2E55-4814-445D-BBA0-685C41CA1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7FC83F-CEAD-489C-A396-7FC38D97E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6678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1DD3DE-E0A0-4A90-992E-2EAEEA26E6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CE14DC-24AB-449A-A531-20650909CD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DF2D83-6185-427B-9E4E-9A9AB28F6B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BB10D-8B9C-4B61-A731-BEEF76D059DB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E06C31-E384-40E5-A7CC-2057FF6976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1F27EA-4063-4E2F-95C3-0FC2FB1F80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F1A9C-4F76-4A45-9979-E0A916D510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8342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6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2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12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23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4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0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3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"/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6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tint val="95000"/>
            <a:satMod val="1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Text, letter&#10;&#10;Description automatically generated">
            <a:extLst>
              <a:ext uri="{FF2B5EF4-FFF2-40B4-BE49-F238E27FC236}">
                <a16:creationId xmlns:a16="http://schemas.microsoft.com/office/drawing/2014/main" id="{BDFDBDAD-C292-44D6-AF5F-703C59CE331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97" r="-1" b="1535"/>
          <a:stretch/>
        </p:blipFill>
        <p:spPr>
          <a:xfrm>
            <a:off x="321733" y="321733"/>
            <a:ext cx="11548534" cy="6214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8881227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ap&#10;&#10;Description automatically generated">
            <a:extLst>
              <a:ext uri="{FF2B5EF4-FFF2-40B4-BE49-F238E27FC236}">
                <a16:creationId xmlns:a16="http://schemas.microsoft.com/office/drawing/2014/main" id="{BAB93211-41B4-46D7-B608-6A793F0A7D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86095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picture containing map&#10;&#10;Description automatically generated">
            <a:extLst>
              <a:ext uri="{FF2B5EF4-FFF2-40B4-BE49-F238E27FC236}">
                <a16:creationId xmlns:a16="http://schemas.microsoft.com/office/drawing/2014/main" id="{0BB8DAE5-A384-4147-8272-7D4B33B801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10663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Diagram&#10;&#10;Description automatically generated">
            <a:extLst>
              <a:ext uri="{FF2B5EF4-FFF2-40B4-BE49-F238E27FC236}">
                <a16:creationId xmlns:a16="http://schemas.microsoft.com/office/drawing/2014/main" id="{B5057347-4169-4C1C-8442-03082B4679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26614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42B6559F-B77B-424F-B6F8-E6E8CFF4FB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93061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F0264C68-D670-49F1-9A17-5AD27B3F7B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71554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B237E77D-00A4-4DD1-8B2F-AD9400EB8C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153744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D12920C0-0E63-4E91-8439-E104593033C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096521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gram&#10;&#10;Description automatically generated">
            <a:extLst>
              <a:ext uri="{FF2B5EF4-FFF2-40B4-BE49-F238E27FC236}">
                <a16:creationId xmlns:a16="http://schemas.microsoft.com/office/drawing/2014/main" id="{9A149899-EEC0-481F-BDC5-CE4BCD770F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576861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0AF298EC-097D-4107-93D7-B0EDF883754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693725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gram&#10;&#10;Description automatically generated">
            <a:extLst>
              <a:ext uri="{FF2B5EF4-FFF2-40B4-BE49-F238E27FC236}">
                <a16:creationId xmlns:a16="http://schemas.microsoft.com/office/drawing/2014/main" id="{210248A9-7C84-4BA8-98EA-B7C748E0C66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57388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picture containing chart&#10;&#10;Description automatically generated">
            <a:extLst>
              <a:ext uri="{FF2B5EF4-FFF2-40B4-BE49-F238E27FC236}">
                <a16:creationId xmlns:a16="http://schemas.microsoft.com/office/drawing/2014/main" id="{14A4E253-D35A-4981-8FE0-3F2267F1F7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153562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FB209004-072C-4044-8CF5-D98B352613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72127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Map&#10;&#10;Description automatically generated">
            <a:extLst>
              <a:ext uri="{FF2B5EF4-FFF2-40B4-BE49-F238E27FC236}">
                <a16:creationId xmlns:a16="http://schemas.microsoft.com/office/drawing/2014/main" id="{FB6F0987-ECBE-4EAB-BC0C-36666C4EC8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484470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map&#10;&#10;Description automatically generated">
            <a:extLst>
              <a:ext uri="{FF2B5EF4-FFF2-40B4-BE49-F238E27FC236}">
                <a16:creationId xmlns:a16="http://schemas.microsoft.com/office/drawing/2014/main" id="{AC903DE6-763F-44F2-A1C8-F822078A6C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491122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text, application, email&#10;&#10;Description automatically generated">
            <a:extLst>
              <a:ext uri="{FF2B5EF4-FFF2-40B4-BE49-F238E27FC236}">
                <a16:creationId xmlns:a16="http://schemas.microsoft.com/office/drawing/2014/main" id="{76B5D87C-C814-4388-AFCC-BE82A4706B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232289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7" name="Picture 6" descr="Table&#10;&#10;Description automatically generated">
            <a:extLst>
              <a:ext uri="{FF2B5EF4-FFF2-40B4-BE49-F238E27FC236}">
                <a16:creationId xmlns:a16="http://schemas.microsoft.com/office/drawing/2014/main" id="{6EE6086D-D34C-4734-95AE-8864DE3D564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"/>
          <a:stretch/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094526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Diagram&#10;&#10;Description automatically generated">
            <a:extLst>
              <a:ext uri="{FF2B5EF4-FFF2-40B4-BE49-F238E27FC236}">
                <a16:creationId xmlns:a16="http://schemas.microsoft.com/office/drawing/2014/main" id="{A4C836E2-FD67-4531-901B-8F354FB400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826009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BA78DFD4-45B8-4CD0-B3D4-8C9D12186B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201419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tint val="95000"/>
            <a:satMod val="1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A7A67D1B-37A9-4C1B-837E-C2CA2BEE86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33" r="-1" b="1900"/>
          <a:stretch/>
        </p:blipFill>
        <p:spPr>
          <a:xfrm>
            <a:off x="321733" y="321733"/>
            <a:ext cx="11548534" cy="6214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239792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9" name="Picture 8" descr="Chart&#10;&#10;Description automatically generated">
            <a:extLst>
              <a:ext uri="{FF2B5EF4-FFF2-40B4-BE49-F238E27FC236}">
                <a16:creationId xmlns:a16="http://schemas.microsoft.com/office/drawing/2014/main" id="{CC6EDF31-1A82-4990-9BAE-E0B25C6D6AE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"/>
          <a:stretch/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86187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picture containing map&#10;&#10;Description automatically generated">
            <a:extLst>
              <a:ext uri="{FF2B5EF4-FFF2-40B4-BE49-F238E27FC236}">
                <a16:creationId xmlns:a16="http://schemas.microsoft.com/office/drawing/2014/main" id="{2E24F4AC-A886-442E-8A19-C41E32F2836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8579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map&#10;&#10;Description automatically generated">
            <a:extLst>
              <a:ext uri="{FF2B5EF4-FFF2-40B4-BE49-F238E27FC236}">
                <a16:creationId xmlns:a16="http://schemas.microsoft.com/office/drawing/2014/main" id="{091DC777-63B0-4AAC-A264-6270FA75B7B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99099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2EB9A692-0807-4045-A37A-8CDB0D86CD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86874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ap&#10;&#10;Description automatically generated">
            <a:extLst>
              <a:ext uri="{FF2B5EF4-FFF2-40B4-BE49-F238E27FC236}">
                <a16:creationId xmlns:a16="http://schemas.microsoft.com/office/drawing/2014/main" id="{7E3F5F36-5E6F-4911-9335-7ADE2DA2BA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8126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9105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7D4D25D3-BA22-4FB7-9D43-EFCD6DA283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41161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map&#10;&#10;Description automatically generated">
            <a:extLst>
              <a:ext uri="{FF2B5EF4-FFF2-40B4-BE49-F238E27FC236}">
                <a16:creationId xmlns:a16="http://schemas.microsoft.com/office/drawing/2014/main" id="{52D01181-B88C-475D-8D8A-24984148E3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22134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map&#10;&#10;Description automatically generated">
            <a:extLst>
              <a:ext uri="{FF2B5EF4-FFF2-40B4-BE49-F238E27FC236}">
                <a16:creationId xmlns:a16="http://schemas.microsoft.com/office/drawing/2014/main" id="{C8EDF301-37F6-436A-9D83-82A035BADB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37765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4D5B189A-EC33-481A-A546-72C870C4B5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3114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</TotalTime>
  <Words>596</Words>
  <Application>Microsoft Office PowerPoint</Application>
  <PresentationFormat>Widescreen</PresentationFormat>
  <Paragraphs>32</Paragraphs>
  <Slides>29</Slides>
  <Notes>1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a Prahl</dc:creator>
  <cp:lastModifiedBy>Rosa Prahl</cp:lastModifiedBy>
  <cp:revision>16</cp:revision>
  <dcterms:created xsi:type="dcterms:W3CDTF">2020-12-13T00:47:14Z</dcterms:created>
  <dcterms:modified xsi:type="dcterms:W3CDTF">2021-06-03T00:45:57Z</dcterms:modified>
</cp:coreProperties>
</file>